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9888" autoAdjust="0"/>
  </p:normalViewPr>
  <p:slideViewPr>
    <p:cSldViewPr snapToGrid="0" snapToObjects="1">
      <p:cViewPr>
        <p:scale>
          <a:sx n="100" d="100"/>
          <a:sy n="100" d="100"/>
        </p:scale>
        <p:origin x="-858" y="-29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627CE-E67B-2E4E-B4DD-8803E50E265D}" type="datetimeFigureOut">
              <a:rPr lang="en-US" smtClean="0"/>
              <a:pPr/>
              <a:t>7/2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D020B5-7606-E943-849E-16931D0CE39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8736423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627CE-E67B-2E4E-B4DD-8803E50E265D}" type="datetimeFigureOut">
              <a:rPr lang="en-US" smtClean="0"/>
              <a:pPr/>
              <a:t>7/2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D020B5-7606-E943-849E-16931D0CE39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0283664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627CE-E67B-2E4E-B4DD-8803E50E265D}" type="datetimeFigureOut">
              <a:rPr lang="en-US" smtClean="0"/>
              <a:pPr/>
              <a:t>7/2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D020B5-7606-E943-849E-16931D0CE39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9445840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627CE-E67B-2E4E-B4DD-8803E50E265D}" type="datetimeFigureOut">
              <a:rPr lang="en-US" smtClean="0"/>
              <a:pPr/>
              <a:t>7/2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D020B5-7606-E943-849E-16931D0CE39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6537664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627CE-E67B-2E4E-B4DD-8803E50E265D}" type="datetimeFigureOut">
              <a:rPr lang="en-US" smtClean="0"/>
              <a:pPr/>
              <a:t>7/2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D020B5-7606-E943-849E-16931D0CE39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9551964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627CE-E67B-2E4E-B4DD-8803E50E265D}" type="datetimeFigureOut">
              <a:rPr lang="en-US" smtClean="0"/>
              <a:pPr/>
              <a:t>7/20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D020B5-7606-E943-849E-16931D0CE39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6481553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627CE-E67B-2E4E-B4DD-8803E50E265D}" type="datetimeFigureOut">
              <a:rPr lang="en-US" smtClean="0"/>
              <a:pPr/>
              <a:t>7/20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D020B5-7606-E943-849E-16931D0CE39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0504752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627CE-E67B-2E4E-B4DD-8803E50E265D}" type="datetimeFigureOut">
              <a:rPr lang="en-US" smtClean="0"/>
              <a:pPr/>
              <a:t>7/20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D020B5-7606-E943-849E-16931D0CE39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42453834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627CE-E67B-2E4E-B4DD-8803E50E265D}" type="datetimeFigureOut">
              <a:rPr lang="en-US" smtClean="0"/>
              <a:pPr/>
              <a:t>7/20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D020B5-7606-E943-849E-16931D0CE39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8961790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627CE-E67B-2E4E-B4DD-8803E50E265D}" type="datetimeFigureOut">
              <a:rPr lang="en-US" smtClean="0"/>
              <a:pPr/>
              <a:t>7/20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D020B5-7606-E943-849E-16931D0CE39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6240504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627CE-E67B-2E4E-B4DD-8803E50E265D}" type="datetimeFigureOut">
              <a:rPr lang="en-US" smtClean="0"/>
              <a:pPr/>
              <a:t>7/20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D020B5-7606-E943-849E-16931D0CE39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2752737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8627CE-E67B-2E4E-B4DD-8803E50E265D}" type="datetimeFigureOut">
              <a:rPr lang="en-US" smtClean="0"/>
              <a:pPr/>
              <a:t>7/2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D020B5-7606-E943-849E-16931D0CE39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0860570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TextBox 49"/>
          <p:cNvSpPr txBox="1"/>
          <p:nvPr/>
        </p:nvSpPr>
        <p:spPr>
          <a:xfrm>
            <a:off x="1171575" y="4394200"/>
            <a:ext cx="6791325" cy="17235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upplementary Figure 1. </a:t>
            </a:r>
            <a:r>
              <a:rPr lang="en-US" sz="1200" dirty="0" err="1" smtClean="0"/>
              <a:t>Quantitiative</a:t>
            </a:r>
            <a:r>
              <a:rPr lang="en-US" sz="1200" dirty="0" smtClean="0"/>
              <a:t> </a:t>
            </a:r>
            <a:r>
              <a:rPr lang="en-US" sz="1200" dirty="0" err="1" smtClean="0"/>
              <a:t>immunohistochemistry</a:t>
            </a:r>
            <a:r>
              <a:rPr lang="en-US" sz="1200" dirty="0" smtClean="0"/>
              <a:t> analysis. In order to provide objectivity about selection of </a:t>
            </a:r>
            <a:r>
              <a:rPr lang="en-US" sz="1200" dirty="0" err="1" smtClean="0"/>
              <a:t>tumour</a:t>
            </a:r>
            <a:r>
              <a:rPr lang="en-US" sz="1200" dirty="0" smtClean="0"/>
              <a:t> areas for measurement of intra-</a:t>
            </a:r>
            <a:r>
              <a:rPr lang="en-US" sz="1200" dirty="0" err="1" smtClean="0"/>
              <a:t>tumoral</a:t>
            </a:r>
            <a:r>
              <a:rPr lang="en-US" sz="1200" dirty="0" smtClean="0"/>
              <a:t> differences, a strict algorithm for region of interest selection was followed in every case.</a:t>
            </a:r>
          </a:p>
          <a:p>
            <a:r>
              <a:rPr lang="en-US" sz="1200" dirty="0" smtClean="0"/>
              <a:t>Line 1 was drawn across the whole width of the </a:t>
            </a:r>
            <a:r>
              <a:rPr lang="en-US" sz="1200" dirty="0" err="1" smtClean="0"/>
              <a:t>tumour</a:t>
            </a:r>
            <a:r>
              <a:rPr lang="en-US" sz="1200" dirty="0" smtClean="0"/>
              <a:t> section across the </a:t>
            </a:r>
            <a:r>
              <a:rPr lang="en-US" sz="1200" dirty="0" err="1" smtClean="0"/>
              <a:t>tumour</a:t>
            </a:r>
            <a:r>
              <a:rPr lang="en-US" sz="1200" dirty="0" smtClean="0"/>
              <a:t>-liver </a:t>
            </a:r>
            <a:r>
              <a:rPr lang="en-US" sz="1200" dirty="0" smtClean="0"/>
              <a:t>interface.</a:t>
            </a:r>
            <a:endParaRPr lang="en-US" sz="1200" dirty="0" smtClean="0"/>
          </a:p>
          <a:p>
            <a:r>
              <a:rPr lang="en-US" sz="1200" dirty="0" smtClean="0"/>
              <a:t>Line 2 was placed perpendicular to and </a:t>
            </a:r>
            <a:r>
              <a:rPr lang="en-US" sz="1200" dirty="0" err="1" smtClean="0"/>
              <a:t>bissecting</a:t>
            </a:r>
            <a:r>
              <a:rPr lang="en-US" sz="1200" dirty="0" smtClean="0"/>
              <a:t> line 1 to the central margin of the </a:t>
            </a:r>
            <a:r>
              <a:rPr lang="en-US" sz="1200" dirty="0" err="1" smtClean="0"/>
              <a:t>tumour</a:t>
            </a:r>
            <a:r>
              <a:rPr lang="en-US" sz="1200" dirty="0" smtClean="0"/>
              <a:t> </a:t>
            </a:r>
            <a:r>
              <a:rPr lang="en-US" sz="1200" dirty="0" smtClean="0"/>
              <a:t>section.</a:t>
            </a:r>
            <a:endParaRPr lang="en-US" sz="1200" dirty="0" smtClean="0"/>
          </a:p>
          <a:p>
            <a:r>
              <a:rPr lang="en-US" sz="1200" dirty="0" smtClean="0"/>
              <a:t>Line 2 was divided into thirds so that the outer thirds represented the central area and peripheral </a:t>
            </a:r>
            <a:r>
              <a:rPr lang="en-US" sz="1200" dirty="0" smtClean="0"/>
              <a:t>area.</a:t>
            </a:r>
            <a:endParaRPr lang="en-US" sz="1200" dirty="0" smtClean="0"/>
          </a:p>
          <a:p>
            <a:r>
              <a:rPr lang="en-US" sz="1200" dirty="0" smtClean="0"/>
              <a:t>Boxes 150um wide were placed on top of the outer thirds of Line 2 </a:t>
            </a:r>
            <a:r>
              <a:rPr lang="en-US" sz="1200" dirty="0" smtClean="0"/>
              <a:t>giving </a:t>
            </a:r>
            <a:r>
              <a:rPr lang="en-US" sz="1200" dirty="0" smtClean="0"/>
              <a:t>regions of interest for </a:t>
            </a:r>
            <a:r>
              <a:rPr lang="en-US" sz="1200" dirty="0" smtClean="0"/>
              <a:t>counting.</a:t>
            </a:r>
            <a:endParaRPr lang="en-US" sz="1200" dirty="0" smtClean="0"/>
          </a:p>
          <a:p>
            <a:r>
              <a:rPr lang="en-US" sz="1200" dirty="0" smtClean="0"/>
              <a:t> </a:t>
            </a:r>
          </a:p>
          <a:p>
            <a:endParaRPr lang="en-US" sz="1000" dirty="0"/>
          </a:p>
        </p:txBody>
      </p:sp>
      <p:grpSp>
        <p:nvGrpSpPr>
          <p:cNvPr id="22" name="Group 21"/>
          <p:cNvGrpSpPr/>
          <p:nvPr/>
        </p:nvGrpSpPr>
        <p:grpSpPr>
          <a:xfrm>
            <a:off x="1631807" y="1692288"/>
            <a:ext cx="4780637" cy="2496312"/>
            <a:chOff x="1908032" y="1692288"/>
            <a:chExt cx="4780637" cy="2496312"/>
          </a:xfrm>
        </p:grpSpPr>
        <p:sp>
          <p:nvSpPr>
            <p:cNvPr id="13" name="Oval 12"/>
            <p:cNvSpPr/>
            <p:nvPr/>
          </p:nvSpPr>
          <p:spPr>
            <a:xfrm>
              <a:off x="3039533" y="1969286"/>
              <a:ext cx="3589867" cy="2204773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7" name="Cloud 46"/>
            <p:cNvSpPr/>
            <p:nvPr/>
          </p:nvSpPr>
          <p:spPr>
            <a:xfrm>
              <a:off x="3018271" y="1920897"/>
              <a:ext cx="3539067" cy="649138"/>
            </a:xfrm>
            <a:prstGeom prst="cloud">
              <a:avLst/>
            </a:prstGeom>
            <a:solidFill>
              <a:srgbClr val="D9D9D9"/>
            </a:solidFill>
            <a:ln>
              <a:solidFill>
                <a:srgbClr val="D9D9D9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Freeform 4"/>
            <p:cNvSpPr/>
            <p:nvPr/>
          </p:nvSpPr>
          <p:spPr>
            <a:xfrm>
              <a:off x="2990212" y="1920897"/>
              <a:ext cx="3698455" cy="1822221"/>
            </a:xfrm>
            <a:custGeom>
              <a:avLst/>
              <a:gdLst>
                <a:gd name="connsiteX0" fmla="*/ 25488 w 3513754"/>
                <a:gd name="connsiteY0" fmla="*/ 440266 h 1989666"/>
                <a:gd name="connsiteX1" fmla="*/ 25488 w 3513754"/>
                <a:gd name="connsiteY1" fmla="*/ 440266 h 1989666"/>
                <a:gd name="connsiteX2" fmla="*/ 17021 w 3513754"/>
                <a:gd name="connsiteY2" fmla="*/ 516466 h 1989666"/>
                <a:gd name="connsiteX3" fmla="*/ 33954 w 3513754"/>
                <a:gd name="connsiteY3" fmla="*/ 694266 h 1989666"/>
                <a:gd name="connsiteX4" fmla="*/ 42421 w 3513754"/>
                <a:gd name="connsiteY4" fmla="*/ 719666 h 1989666"/>
                <a:gd name="connsiteX5" fmla="*/ 50888 w 3513754"/>
                <a:gd name="connsiteY5" fmla="*/ 753533 h 1989666"/>
                <a:gd name="connsiteX6" fmla="*/ 67821 w 3513754"/>
                <a:gd name="connsiteY6" fmla="*/ 812800 h 1989666"/>
                <a:gd name="connsiteX7" fmla="*/ 84754 w 3513754"/>
                <a:gd name="connsiteY7" fmla="*/ 939800 h 1989666"/>
                <a:gd name="connsiteX8" fmla="*/ 110154 w 3513754"/>
                <a:gd name="connsiteY8" fmla="*/ 1032933 h 1989666"/>
                <a:gd name="connsiteX9" fmla="*/ 118621 w 3513754"/>
                <a:gd name="connsiteY9" fmla="*/ 1058333 h 1989666"/>
                <a:gd name="connsiteX10" fmla="*/ 127088 w 3513754"/>
                <a:gd name="connsiteY10" fmla="*/ 1083733 h 1989666"/>
                <a:gd name="connsiteX11" fmla="*/ 177888 w 3513754"/>
                <a:gd name="connsiteY11" fmla="*/ 1126066 h 1989666"/>
                <a:gd name="connsiteX12" fmla="*/ 186354 w 3513754"/>
                <a:gd name="connsiteY12" fmla="*/ 1151466 h 1989666"/>
                <a:gd name="connsiteX13" fmla="*/ 203288 w 3513754"/>
                <a:gd name="connsiteY13" fmla="*/ 1219200 h 1989666"/>
                <a:gd name="connsiteX14" fmla="*/ 220221 w 3513754"/>
                <a:gd name="connsiteY14" fmla="*/ 1337733 h 1989666"/>
                <a:gd name="connsiteX15" fmla="*/ 245621 w 3513754"/>
                <a:gd name="connsiteY15" fmla="*/ 1388533 h 1989666"/>
                <a:gd name="connsiteX16" fmla="*/ 287954 w 3513754"/>
                <a:gd name="connsiteY16" fmla="*/ 1422400 h 1989666"/>
                <a:gd name="connsiteX17" fmla="*/ 321821 w 3513754"/>
                <a:gd name="connsiteY17" fmla="*/ 1473200 h 1989666"/>
                <a:gd name="connsiteX18" fmla="*/ 330288 w 3513754"/>
                <a:gd name="connsiteY18" fmla="*/ 1498600 h 1989666"/>
                <a:gd name="connsiteX19" fmla="*/ 364154 w 3513754"/>
                <a:gd name="connsiteY19" fmla="*/ 1532466 h 1989666"/>
                <a:gd name="connsiteX20" fmla="*/ 372621 w 3513754"/>
                <a:gd name="connsiteY20" fmla="*/ 1557866 h 1989666"/>
                <a:gd name="connsiteX21" fmla="*/ 448821 w 3513754"/>
                <a:gd name="connsiteY21" fmla="*/ 1617133 h 1989666"/>
                <a:gd name="connsiteX22" fmla="*/ 499621 w 3513754"/>
                <a:gd name="connsiteY22" fmla="*/ 1634066 h 1989666"/>
                <a:gd name="connsiteX23" fmla="*/ 516554 w 3513754"/>
                <a:gd name="connsiteY23" fmla="*/ 1651000 h 1989666"/>
                <a:gd name="connsiteX24" fmla="*/ 541954 w 3513754"/>
                <a:gd name="connsiteY24" fmla="*/ 1659466 h 1989666"/>
                <a:gd name="connsiteX25" fmla="*/ 592754 w 3513754"/>
                <a:gd name="connsiteY25" fmla="*/ 1710266 h 1989666"/>
                <a:gd name="connsiteX26" fmla="*/ 652021 w 3513754"/>
                <a:gd name="connsiteY26" fmla="*/ 1744133 h 1989666"/>
                <a:gd name="connsiteX27" fmla="*/ 677421 w 3513754"/>
                <a:gd name="connsiteY27" fmla="*/ 1752600 h 1989666"/>
                <a:gd name="connsiteX28" fmla="*/ 711288 w 3513754"/>
                <a:gd name="connsiteY28" fmla="*/ 1794933 h 1989666"/>
                <a:gd name="connsiteX29" fmla="*/ 736688 w 3513754"/>
                <a:gd name="connsiteY29" fmla="*/ 1837266 h 1989666"/>
                <a:gd name="connsiteX30" fmla="*/ 762088 w 3513754"/>
                <a:gd name="connsiteY30" fmla="*/ 1854200 h 1989666"/>
                <a:gd name="connsiteX31" fmla="*/ 795954 w 3513754"/>
                <a:gd name="connsiteY31" fmla="*/ 1879600 h 1989666"/>
                <a:gd name="connsiteX32" fmla="*/ 829821 w 3513754"/>
                <a:gd name="connsiteY32" fmla="*/ 1913466 h 1989666"/>
                <a:gd name="connsiteX33" fmla="*/ 948354 w 3513754"/>
                <a:gd name="connsiteY33" fmla="*/ 1930400 h 1989666"/>
                <a:gd name="connsiteX34" fmla="*/ 1033021 w 3513754"/>
                <a:gd name="connsiteY34" fmla="*/ 1938866 h 1989666"/>
                <a:gd name="connsiteX35" fmla="*/ 1092288 w 3513754"/>
                <a:gd name="connsiteY35" fmla="*/ 1947333 h 1989666"/>
                <a:gd name="connsiteX36" fmla="*/ 1270088 w 3513754"/>
                <a:gd name="connsiteY36" fmla="*/ 1972733 h 1989666"/>
                <a:gd name="connsiteX37" fmla="*/ 1541021 w 3513754"/>
                <a:gd name="connsiteY37" fmla="*/ 1989666 h 1989666"/>
                <a:gd name="connsiteX38" fmla="*/ 2514688 w 3513754"/>
                <a:gd name="connsiteY38" fmla="*/ 1972733 h 1989666"/>
                <a:gd name="connsiteX39" fmla="*/ 2557021 w 3513754"/>
                <a:gd name="connsiteY39" fmla="*/ 1964266 h 1989666"/>
                <a:gd name="connsiteX40" fmla="*/ 2675554 w 3513754"/>
                <a:gd name="connsiteY40" fmla="*/ 1921933 h 1989666"/>
                <a:gd name="connsiteX41" fmla="*/ 2726354 w 3513754"/>
                <a:gd name="connsiteY41" fmla="*/ 1905000 h 1989666"/>
                <a:gd name="connsiteX42" fmla="*/ 2785621 w 3513754"/>
                <a:gd name="connsiteY42" fmla="*/ 1862666 h 1989666"/>
                <a:gd name="connsiteX43" fmla="*/ 2870288 w 3513754"/>
                <a:gd name="connsiteY43" fmla="*/ 1803400 h 1989666"/>
                <a:gd name="connsiteX44" fmla="*/ 2895688 w 3513754"/>
                <a:gd name="connsiteY44" fmla="*/ 1794933 h 1989666"/>
                <a:gd name="connsiteX45" fmla="*/ 2938021 w 3513754"/>
                <a:gd name="connsiteY45" fmla="*/ 1744133 h 1989666"/>
                <a:gd name="connsiteX46" fmla="*/ 2963421 w 3513754"/>
                <a:gd name="connsiteY46" fmla="*/ 1735666 h 1989666"/>
                <a:gd name="connsiteX47" fmla="*/ 2988821 w 3513754"/>
                <a:gd name="connsiteY47" fmla="*/ 1718733 h 1989666"/>
                <a:gd name="connsiteX48" fmla="*/ 3005754 w 3513754"/>
                <a:gd name="connsiteY48" fmla="*/ 1693333 h 1989666"/>
                <a:gd name="connsiteX49" fmla="*/ 3039621 w 3513754"/>
                <a:gd name="connsiteY49" fmla="*/ 1667933 h 1989666"/>
                <a:gd name="connsiteX50" fmla="*/ 3115821 w 3513754"/>
                <a:gd name="connsiteY50" fmla="*/ 1625600 h 1989666"/>
                <a:gd name="connsiteX51" fmla="*/ 3183554 w 3513754"/>
                <a:gd name="connsiteY51" fmla="*/ 1574800 h 1989666"/>
                <a:gd name="connsiteX52" fmla="*/ 3225888 w 3513754"/>
                <a:gd name="connsiteY52" fmla="*/ 1524000 h 1989666"/>
                <a:gd name="connsiteX53" fmla="*/ 3268221 w 3513754"/>
                <a:gd name="connsiteY53" fmla="*/ 1473200 h 1989666"/>
                <a:gd name="connsiteX54" fmla="*/ 3276688 w 3513754"/>
                <a:gd name="connsiteY54" fmla="*/ 1447800 h 1989666"/>
                <a:gd name="connsiteX55" fmla="*/ 3293621 w 3513754"/>
                <a:gd name="connsiteY55" fmla="*/ 1422400 h 1989666"/>
                <a:gd name="connsiteX56" fmla="*/ 3310554 w 3513754"/>
                <a:gd name="connsiteY56" fmla="*/ 1363133 h 1989666"/>
                <a:gd name="connsiteX57" fmla="*/ 3335954 w 3513754"/>
                <a:gd name="connsiteY57" fmla="*/ 1320800 h 1989666"/>
                <a:gd name="connsiteX58" fmla="*/ 3352888 w 3513754"/>
                <a:gd name="connsiteY58" fmla="*/ 1270000 h 1989666"/>
                <a:gd name="connsiteX59" fmla="*/ 3361354 w 3513754"/>
                <a:gd name="connsiteY59" fmla="*/ 1244600 h 1989666"/>
                <a:gd name="connsiteX60" fmla="*/ 3369821 w 3513754"/>
                <a:gd name="connsiteY60" fmla="*/ 1168400 h 1989666"/>
                <a:gd name="connsiteX61" fmla="*/ 3386754 w 3513754"/>
                <a:gd name="connsiteY61" fmla="*/ 1126066 h 1989666"/>
                <a:gd name="connsiteX62" fmla="*/ 3395221 w 3513754"/>
                <a:gd name="connsiteY62" fmla="*/ 990600 h 1989666"/>
                <a:gd name="connsiteX63" fmla="*/ 3412154 w 3513754"/>
                <a:gd name="connsiteY63" fmla="*/ 905933 h 1989666"/>
                <a:gd name="connsiteX64" fmla="*/ 3429088 w 3513754"/>
                <a:gd name="connsiteY64" fmla="*/ 829733 h 1989666"/>
                <a:gd name="connsiteX65" fmla="*/ 3446021 w 3513754"/>
                <a:gd name="connsiteY65" fmla="*/ 787400 h 1989666"/>
                <a:gd name="connsiteX66" fmla="*/ 3454488 w 3513754"/>
                <a:gd name="connsiteY66" fmla="*/ 736600 h 1989666"/>
                <a:gd name="connsiteX67" fmla="*/ 3471421 w 3513754"/>
                <a:gd name="connsiteY67" fmla="*/ 643466 h 1989666"/>
                <a:gd name="connsiteX68" fmla="*/ 3479888 w 3513754"/>
                <a:gd name="connsiteY68" fmla="*/ 584200 h 1989666"/>
                <a:gd name="connsiteX69" fmla="*/ 3505288 w 3513754"/>
                <a:gd name="connsiteY69" fmla="*/ 499533 h 1989666"/>
                <a:gd name="connsiteX70" fmla="*/ 3513754 w 3513754"/>
                <a:gd name="connsiteY70" fmla="*/ 465666 h 1989666"/>
                <a:gd name="connsiteX71" fmla="*/ 3505288 w 3513754"/>
                <a:gd name="connsiteY71" fmla="*/ 313266 h 1989666"/>
                <a:gd name="connsiteX72" fmla="*/ 3496821 w 3513754"/>
                <a:gd name="connsiteY72" fmla="*/ 279400 h 1989666"/>
                <a:gd name="connsiteX73" fmla="*/ 3479888 w 3513754"/>
                <a:gd name="connsiteY73" fmla="*/ 262466 h 1989666"/>
                <a:gd name="connsiteX74" fmla="*/ 3454488 w 3513754"/>
                <a:gd name="connsiteY74" fmla="*/ 127000 h 1989666"/>
                <a:gd name="connsiteX75" fmla="*/ 3446021 w 3513754"/>
                <a:gd name="connsiteY75" fmla="*/ 101600 h 1989666"/>
                <a:gd name="connsiteX76" fmla="*/ 3412154 w 3513754"/>
                <a:gd name="connsiteY76" fmla="*/ 67733 h 1989666"/>
                <a:gd name="connsiteX77" fmla="*/ 3378288 w 3513754"/>
                <a:gd name="connsiteY77" fmla="*/ 59266 h 1989666"/>
                <a:gd name="connsiteX78" fmla="*/ 3310554 w 3513754"/>
                <a:gd name="connsiteY78" fmla="*/ 42333 h 1989666"/>
                <a:gd name="connsiteX79" fmla="*/ 3115821 w 3513754"/>
                <a:gd name="connsiteY79" fmla="*/ 25400 h 1989666"/>
                <a:gd name="connsiteX80" fmla="*/ 2963421 w 3513754"/>
                <a:gd name="connsiteY80" fmla="*/ 16933 h 1989666"/>
                <a:gd name="connsiteX81" fmla="*/ 2912621 w 3513754"/>
                <a:gd name="connsiteY81" fmla="*/ 8466 h 1989666"/>
                <a:gd name="connsiteX82" fmla="*/ 2878754 w 3513754"/>
                <a:gd name="connsiteY82" fmla="*/ 0 h 1989666"/>
                <a:gd name="connsiteX83" fmla="*/ 2667088 w 3513754"/>
                <a:gd name="connsiteY83" fmla="*/ 8466 h 1989666"/>
                <a:gd name="connsiteX84" fmla="*/ 2616288 w 3513754"/>
                <a:gd name="connsiteY84" fmla="*/ 25400 h 1989666"/>
                <a:gd name="connsiteX85" fmla="*/ 2573954 w 3513754"/>
                <a:gd name="connsiteY85" fmla="*/ 33866 h 1989666"/>
                <a:gd name="connsiteX86" fmla="*/ 2015154 w 3513754"/>
                <a:gd name="connsiteY86" fmla="*/ 42333 h 1989666"/>
                <a:gd name="connsiteX87" fmla="*/ 1972821 w 3513754"/>
                <a:gd name="connsiteY87" fmla="*/ 50800 h 1989666"/>
                <a:gd name="connsiteX88" fmla="*/ 1913554 w 3513754"/>
                <a:gd name="connsiteY88" fmla="*/ 67733 h 1989666"/>
                <a:gd name="connsiteX89" fmla="*/ 1871221 w 3513754"/>
                <a:gd name="connsiteY89" fmla="*/ 76200 h 1989666"/>
                <a:gd name="connsiteX90" fmla="*/ 1845821 w 3513754"/>
                <a:gd name="connsiteY90" fmla="*/ 84666 h 1989666"/>
                <a:gd name="connsiteX91" fmla="*/ 635088 w 3513754"/>
                <a:gd name="connsiteY91" fmla="*/ 93133 h 1989666"/>
                <a:gd name="connsiteX92" fmla="*/ 533488 w 3513754"/>
                <a:gd name="connsiteY92" fmla="*/ 110066 h 1989666"/>
                <a:gd name="connsiteX93" fmla="*/ 448821 w 3513754"/>
                <a:gd name="connsiteY93" fmla="*/ 127000 h 1989666"/>
                <a:gd name="connsiteX94" fmla="*/ 364154 w 3513754"/>
                <a:gd name="connsiteY94" fmla="*/ 135466 h 1989666"/>
                <a:gd name="connsiteX95" fmla="*/ 279488 w 3513754"/>
                <a:gd name="connsiteY95" fmla="*/ 152400 h 1989666"/>
                <a:gd name="connsiteX96" fmla="*/ 220221 w 3513754"/>
                <a:gd name="connsiteY96" fmla="*/ 245533 h 1989666"/>
                <a:gd name="connsiteX97" fmla="*/ 101688 w 3513754"/>
                <a:gd name="connsiteY97" fmla="*/ 262466 h 1989666"/>
                <a:gd name="connsiteX98" fmla="*/ 59354 w 3513754"/>
                <a:gd name="connsiteY98" fmla="*/ 287866 h 1989666"/>
                <a:gd name="connsiteX99" fmla="*/ 42421 w 3513754"/>
                <a:gd name="connsiteY99" fmla="*/ 304800 h 1989666"/>
                <a:gd name="connsiteX100" fmla="*/ 17021 w 3513754"/>
                <a:gd name="connsiteY100" fmla="*/ 321733 h 1989666"/>
                <a:gd name="connsiteX101" fmla="*/ 8554 w 3513754"/>
                <a:gd name="connsiteY101" fmla="*/ 372533 h 1989666"/>
                <a:gd name="connsiteX102" fmla="*/ 88 w 3513754"/>
                <a:gd name="connsiteY102" fmla="*/ 406400 h 1989666"/>
                <a:gd name="connsiteX103" fmla="*/ 25488 w 3513754"/>
                <a:gd name="connsiteY103" fmla="*/ 440266 h 198966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</a:cxnLst>
              <a:rect l="l" t="t" r="r" b="b"/>
              <a:pathLst>
                <a:path w="3513754" h="1989666">
                  <a:moveTo>
                    <a:pt x="25488" y="440266"/>
                  </a:moveTo>
                  <a:lnTo>
                    <a:pt x="25488" y="440266"/>
                  </a:lnTo>
                  <a:cubicBezTo>
                    <a:pt x="22666" y="465666"/>
                    <a:pt x="17021" y="490910"/>
                    <a:pt x="17021" y="516466"/>
                  </a:cubicBezTo>
                  <a:cubicBezTo>
                    <a:pt x="17021" y="560098"/>
                    <a:pt x="22401" y="642279"/>
                    <a:pt x="33954" y="694266"/>
                  </a:cubicBezTo>
                  <a:cubicBezTo>
                    <a:pt x="35890" y="702978"/>
                    <a:pt x="39969" y="711085"/>
                    <a:pt x="42421" y="719666"/>
                  </a:cubicBezTo>
                  <a:cubicBezTo>
                    <a:pt x="45618" y="730855"/>
                    <a:pt x="47826" y="742307"/>
                    <a:pt x="50888" y="753533"/>
                  </a:cubicBezTo>
                  <a:cubicBezTo>
                    <a:pt x="56294" y="773355"/>
                    <a:pt x="63201" y="792780"/>
                    <a:pt x="67821" y="812800"/>
                  </a:cubicBezTo>
                  <a:cubicBezTo>
                    <a:pt x="77795" y="856020"/>
                    <a:pt x="78404" y="895351"/>
                    <a:pt x="84754" y="939800"/>
                  </a:cubicBezTo>
                  <a:cubicBezTo>
                    <a:pt x="90737" y="981680"/>
                    <a:pt x="96094" y="990753"/>
                    <a:pt x="110154" y="1032933"/>
                  </a:cubicBezTo>
                  <a:lnTo>
                    <a:pt x="118621" y="1058333"/>
                  </a:lnTo>
                  <a:cubicBezTo>
                    <a:pt x="121443" y="1066800"/>
                    <a:pt x="119948" y="1078378"/>
                    <a:pt x="127088" y="1083733"/>
                  </a:cubicBezTo>
                  <a:cubicBezTo>
                    <a:pt x="167340" y="1113923"/>
                    <a:pt x="150976" y="1099155"/>
                    <a:pt x="177888" y="1126066"/>
                  </a:cubicBezTo>
                  <a:cubicBezTo>
                    <a:pt x="180710" y="1134533"/>
                    <a:pt x="184006" y="1142856"/>
                    <a:pt x="186354" y="1151466"/>
                  </a:cubicBezTo>
                  <a:cubicBezTo>
                    <a:pt x="192477" y="1173919"/>
                    <a:pt x="203288" y="1219200"/>
                    <a:pt x="203288" y="1219200"/>
                  </a:cubicBezTo>
                  <a:cubicBezTo>
                    <a:pt x="210035" y="1286673"/>
                    <a:pt x="206055" y="1288154"/>
                    <a:pt x="220221" y="1337733"/>
                  </a:cubicBezTo>
                  <a:cubicBezTo>
                    <a:pt x="225730" y="1357013"/>
                    <a:pt x="230779" y="1373691"/>
                    <a:pt x="245621" y="1388533"/>
                  </a:cubicBezTo>
                  <a:cubicBezTo>
                    <a:pt x="278953" y="1421865"/>
                    <a:pt x="262814" y="1388879"/>
                    <a:pt x="287954" y="1422400"/>
                  </a:cubicBezTo>
                  <a:cubicBezTo>
                    <a:pt x="300165" y="1438681"/>
                    <a:pt x="315385" y="1453893"/>
                    <a:pt x="321821" y="1473200"/>
                  </a:cubicBezTo>
                  <a:cubicBezTo>
                    <a:pt x="324643" y="1481667"/>
                    <a:pt x="325101" y="1491338"/>
                    <a:pt x="330288" y="1498600"/>
                  </a:cubicBezTo>
                  <a:cubicBezTo>
                    <a:pt x="339567" y="1511591"/>
                    <a:pt x="352865" y="1521177"/>
                    <a:pt x="364154" y="1532466"/>
                  </a:cubicBezTo>
                  <a:cubicBezTo>
                    <a:pt x="366976" y="1540933"/>
                    <a:pt x="367266" y="1550726"/>
                    <a:pt x="372621" y="1557866"/>
                  </a:cubicBezTo>
                  <a:cubicBezTo>
                    <a:pt x="396813" y="1590122"/>
                    <a:pt x="414222" y="1603294"/>
                    <a:pt x="448821" y="1617133"/>
                  </a:cubicBezTo>
                  <a:cubicBezTo>
                    <a:pt x="465394" y="1623762"/>
                    <a:pt x="499621" y="1634066"/>
                    <a:pt x="499621" y="1634066"/>
                  </a:cubicBezTo>
                  <a:cubicBezTo>
                    <a:pt x="505265" y="1639711"/>
                    <a:pt x="509709" y="1646893"/>
                    <a:pt x="516554" y="1651000"/>
                  </a:cubicBezTo>
                  <a:cubicBezTo>
                    <a:pt x="524207" y="1655592"/>
                    <a:pt x="534909" y="1653987"/>
                    <a:pt x="541954" y="1659466"/>
                  </a:cubicBezTo>
                  <a:cubicBezTo>
                    <a:pt x="560857" y="1674168"/>
                    <a:pt x="572829" y="1696982"/>
                    <a:pt x="592754" y="1710266"/>
                  </a:cubicBezTo>
                  <a:cubicBezTo>
                    <a:pt x="618266" y="1727275"/>
                    <a:pt x="621939" y="1731241"/>
                    <a:pt x="652021" y="1744133"/>
                  </a:cubicBezTo>
                  <a:cubicBezTo>
                    <a:pt x="660224" y="1747649"/>
                    <a:pt x="668954" y="1749778"/>
                    <a:pt x="677421" y="1752600"/>
                  </a:cubicBezTo>
                  <a:cubicBezTo>
                    <a:pt x="696958" y="1811210"/>
                    <a:pt x="669509" y="1746192"/>
                    <a:pt x="711288" y="1794933"/>
                  </a:cubicBezTo>
                  <a:cubicBezTo>
                    <a:pt x="721998" y="1807427"/>
                    <a:pt x="725979" y="1824772"/>
                    <a:pt x="736688" y="1837266"/>
                  </a:cubicBezTo>
                  <a:cubicBezTo>
                    <a:pt x="743310" y="1844992"/>
                    <a:pt x="753808" y="1848285"/>
                    <a:pt x="762088" y="1854200"/>
                  </a:cubicBezTo>
                  <a:cubicBezTo>
                    <a:pt x="773570" y="1862402"/>
                    <a:pt x="785334" y="1870308"/>
                    <a:pt x="795954" y="1879600"/>
                  </a:cubicBezTo>
                  <a:cubicBezTo>
                    <a:pt x="807969" y="1890113"/>
                    <a:pt x="814675" y="1908417"/>
                    <a:pt x="829821" y="1913466"/>
                  </a:cubicBezTo>
                  <a:cubicBezTo>
                    <a:pt x="867685" y="1926087"/>
                    <a:pt x="908750" y="1925450"/>
                    <a:pt x="948354" y="1930400"/>
                  </a:cubicBezTo>
                  <a:cubicBezTo>
                    <a:pt x="976498" y="1933918"/>
                    <a:pt x="1004852" y="1935552"/>
                    <a:pt x="1033021" y="1938866"/>
                  </a:cubicBezTo>
                  <a:cubicBezTo>
                    <a:pt x="1052841" y="1941198"/>
                    <a:pt x="1072532" y="1944511"/>
                    <a:pt x="1092288" y="1947333"/>
                  </a:cubicBezTo>
                  <a:cubicBezTo>
                    <a:pt x="1176084" y="1980851"/>
                    <a:pt x="1121076" y="1963967"/>
                    <a:pt x="1270088" y="1972733"/>
                  </a:cubicBezTo>
                  <a:cubicBezTo>
                    <a:pt x="1511835" y="1986954"/>
                    <a:pt x="1332970" y="1974806"/>
                    <a:pt x="1541021" y="1989666"/>
                  </a:cubicBezTo>
                  <a:lnTo>
                    <a:pt x="2514688" y="1972733"/>
                  </a:lnTo>
                  <a:cubicBezTo>
                    <a:pt x="2529074" y="1972373"/>
                    <a:pt x="2543184" y="1968219"/>
                    <a:pt x="2557021" y="1964266"/>
                  </a:cubicBezTo>
                  <a:cubicBezTo>
                    <a:pt x="2647507" y="1938413"/>
                    <a:pt x="2608437" y="1946339"/>
                    <a:pt x="2675554" y="1921933"/>
                  </a:cubicBezTo>
                  <a:cubicBezTo>
                    <a:pt x="2692329" y="1915833"/>
                    <a:pt x="2726354" y="1905000"/>
                    <a:pt x="2726354" y="1905000"/>
                  </a:cubicBezTo>
                  <a:cubicBezTo>
                    <a:pt x="2759695" y="1871659"/>
                    <a:pt x="2726608" y="1902008"/>
                    <a:pt x="2785621" y="1862666"/>
                  </a:cubicBezTo>
                  <a:cubicBezTo>
                    <a:pt x="2804942" y="1849785"/>
                    <a:pt x="2852206" y="1809428"/>
                    <a:pt x="2870288" y="1803400"/>
                  </a:cubicBezTo>
                  <a:lnTo>
                    <a:pt x="2895688" y="1794933"/>
                  </a:lnTo>
                  <a:cubicBezTo>
                    <a:pt x="2908183" y="1776190"/>
                    <a:pt x="2918463" y="1757172"/>
                    <a:pt x="2938021" y="1744133"/>
                  </a:cubicBezTo>
                  <a:cubicBezTo>
                    <a:pt x="2945447" y="1739182"/>
                    <a:pt x="2955439" y="1739657"/>
                    <a:pt x="2963421" y="1735666"/>
                  </a:cubicBezTo>
                  <a:cubicBezTo>
                    <a:pt x="2972522" y="1731115"/>
                    <a:pt x="2980354" y="1724377"/>
                    <a:pt x="2988821" y="1718733"/>
                  </a:cubicBezTo>
                  <a:cubicBezTo>
                    <a:pt x="2994465" y="1710266"/>
                    <a:pt x="2998559" y="1700528"/>
                    <a:pt x="3005754" y="1693333"/>
                  </a:cubicBezTo>
                  <a:cubicBezTo>
                    <a:pt x="3015732" y="1683355"/>
                    <a:pt x="3028061" y="1676025"/>
                    <a:pt x="3039621" y="1667933"/>
                  </a:cubicBezTo>
                  <a:cubicBezTo>
                    <a:pt x="3092555" y="1630879"/>
                    <a:pt x="3073434" y="1639728"/>
                    <a:pt x="3115821" y="1625600"/>
                  </a:cubicBezTo>
                  <a:cubicBezTo>
                    <a:pt x="3158612" y="1582809"/>
                    <a:pt x="3135408" y="1598873"/>
                    <a:pt x="3183554" y="1574800"/>
                  </a:cubicBezTo>
                  <a:cubicBezTo>
                    <a:pt x="3225602" y="1511730"/>
                    <a:pt x="3171556" y="1589198"/>
                    <a:pt x="3225888" y="1524000"/>
                  </a:cubicBezTo>
                  <a:cubicBezTo>
                    <a:pt x="3284825" y="1453274"/>
                    <a:pt x="3194014" y="1547407"/>
                    <a:pt x="3268221" y="1473200"/>
                  </a:cubicBezTo>
                  <a:cubicBezTo>
                    <a:pt x="3271043" y="1464733"/>
                    <a:pt x="3272697" y="1455782"/>
                    <a:pt x="3276688" y="1447800"/>
                  </a:cubicBezTo>
                  <a:cubicBezTo>
                    <a:pt x="3281239" y="1438699"/>
                    <a:pt x="3289842" y="1431848"/>
                    <a:pt x="3293621" y="1422400"/>
                  </a:cubicBezTo>
                  <a:cubicBezTo>
                    <a:pt x="3301251" y="1403323"/>
                    <a:pt x="3302652" y="1382099"/>
                    <a:pt x="3310554" y="1363133"/>
                  </a:cubicBezTo>
                  <a:cubicBezTo>
                    <a:pt x="3316883" y="1347943"/>
                    <a:pt x="3329144" y="1335781"/>
                    <a:pt x="3335954" y="1320800"/>
                  </a:cubicBezTo>
                  <a:cubicBezTo>
                    <a:pt x="3343340" y="1304551"/>
                    <a:pt x="3347244" y="1286933"/>
                    <a:pt x="3352888" y="1270000"/>
                  </a:cubicBezTo>
                  <a:lnTo>
                    <a:pt x="3361354" y="1244600"/>
                  </a:lnTo>
                  <a:cubicBezTo>
                    <a:pt x="3364176" y="1219200"/>
                    <a:pt x="3364466" y="1193389"/>
                    <a:pt x="3369821" y="1168400"/>
                  </a:cubicBezTo>
                  <a:cubicBezTo>
                    <a:pt x="3373005" y="1153539"/>
                    <a:pt x="3384605" y="1141112"/>
                    <a:pt x="3386754" y="1126066"/>
                  </a:cubicBezTo>
                  <a:cubicBezTo>
                    <a:pt x="3393152" y="1081277"/>
                    <a:pt x="3391301" y="1035673"/>
                    <a:pt x="3395221" y="990600"/>
                  </a:cubicBezTo>
                  <a:cubicBezTo>
                    <a:pt x="3403518" y="895193"/>
                    <a:pt x="3398018" y="962476"/>
                    <a:pt x="3412154" y="905933"/>
                  </a:cubicBezTo>
                  <a:cubicBezTo>
                    <a:pt x="3418864" y="879093"/>
                    <a:pt x="3420397" y="855806"/>
                    <a:pt x="3429088" y="829733"/>
                  </a:cubicBezTo>
                  <a:cubicBezTo>
                    <a:pt x="3433894" y="815315"/>
                    <a:pt x="3440377" y="801511"/>
                    <a:pt x="3446021" y="787400"/>
                  </a:cubicBezTo>
                  <a:cubicBezTo>
                    <a:pt x="3448843" y="770467"/>
                    <a:pt x="3451417" y="753490"/>
                    <a:pt x="3454488" y="736600"/>
                  </a:cubicBezTo>
                  <a:cubicBezTo>
                    <a:pt x="3467693" y="663968"/>
                    <a:pt x="3458950" y="724522"/>
                    <a:pt x="3471421" y="643466"/>
                  </a:cubicBezTo>
                  <a:cubicBezTo>
                    <a:pt x="3474456" y="623742"/>
                    <a:pt x="3476318" y="603834"/>
                    <a:pt x="3479888" y="584200"/>
                  </a:cubicBezTo>
                  <a:cubicBezTo>
                    <a:pt x="3488853" y="534892"/>
                    <a:pt x="3490549" y="558495"/>
                    <a:pt x="3505288" y="499533"/>
                  </a:cubicBezTo>
                  <a:lnTo>
                    <a:pt x="3513754" y="465666"/>
                  </a:lnTo>
                  <a:cubicBezTo>
                    <a:pt x="3510932" y="414866"/>
                    <a:pt x="3509894" y="363935"/>
                    <a:pt x="3505288" y="313266"/>
                  </a:cubicBezTo>
                  <a:cubicBezTo>
                    <a:pt x="3504235" y="301678"/>
                    <a:pt x="3502025" y="289808"/>
                    <a:pt x="3496821" y="279400"/>
                  </a:cubicBezTo>
                  <a:cubicBezTo>
                    <a:pt x="3493251" y="272260"/>
                    <a:pt x="3485532" y="268111"/>
                    <a:pt x="3479888" y="262466"/>
                  </a:cubicBezTo>
                  <a:cubicBezTo>
                    <a:pt x="3470956" y="208876"/>
                    <a:pt x="3467920" y="174014"/>
                    <a:pt x="3454488" y="127000"/>
                  </a:cubicBezTo>
                  <a:cubicBezTo>
                    <a:pt x="3452036" y="118419"/>
                    <a:pt x="3451208" y="108862"/>
                    <a:pt x="3446021" y="101600"/>
                  </a:cubicBezTo>
                  <a:cubicBezTo>
                    <a:pt x="3436741" y="88609"/>
                    <a:pt x="3427642" y="71605"/>
                    <a:pt x="3412154" y="67733"/>
                  </a:cubicBezTo>
                  <a:cubicBezTo>
                    <a:pt x="3400865" y="64911"/>
                    <a:pt x="3389476" y="62463"/>
                    <a:pt x="3378288" y="59266"/>
                  </a:cubicBezTo>
                  <a:cubicBezTo>
                    <a:pt x="3345302" y="49841"/>
                    <a:pt x="3351857" y="46758"/>
                    <a:pt x="3310554" y="42333"/>
                  </a:cubicBezTo>
                  <a:cubicBezTo>
                    <a:pt x="3245769" y="35392"/>
                    <a:pt x="3180803" y="30155"/>
                    <a:pt x="3115821" y="25400"/>
                  </a:cubicBezTo>
                  <a:cubicBezTo>
                    <a:pt x="3065078" y="21687"/>
                    <a:pt x="3014221" y="19755"/>
                    <a:pt x="2963421" y="16933"/>
                  </a:cubicBezTo>
                  <a:cubicBezTo>
                    <a:pt x="2946488" y="14111"/>
                    <a:pt x="2929455" y="11833"/>
                    <a:pt x="2912621" y="8466"/>
                  </a:cubicBezTo>
                  <a:cubicBezTo>
                    <a:pt x="2901211" y="6184"/>
                    <a:pt x="2890390" y="0"/>
                    <a:pt x="2878754" y="0"/>
                  </a:cubicBezTo>
                  <a:cubicBezTo>
                    <a:pt x="2808142" y="0"/>
                    <a:pt x="2737643" y="5644"/>
                    <a:pt x="2667088" y="8466"/>
                  </a:cubicBezTo>
                  <a:cubicBezTo>
                    <a:pt x="2650155" y="14111"/>
                    <a:pt x="2633508" y="20704"/>
                    <a:pt x="2616288" y="25400"/>
                  </a:cubicBezTo>
                  <a:cubicBezTo>
                    <a:pt x="2602404" y="29186"/>
                    <a:pt x="2588339" y="33461"/>
                    <a:pt x="2573954" y="33866"/>
                  </a:cubicBezTo>
                  <a:cubicBezTo>
                    <a:pt x="2387740" y="39111"/>
                    <a:pt x="2201421" y="39511"/>
                    <a:pt x="2015154" y="42333"/>
                  </a:cubicBezTo>
                  <a:cubicBezTo>
                    <a:pt x="2001043" y="45155"/>
                    <a:pt x="1986782" y="47310"/>
                    <a:pt x="1972821" y="50800"/>
                  </a:cubicBezTo>
                  <a:cubicBezTo>
                    <a:pt x="1859672" y="79087"/>
                    <a:pt x="2056099" y="36055"/>
                    <a:pt x="1913554" y="67733"/>
                  </a:cubicBezTo>
                  <a:cubicBezTo>
                    <a:pt x="1899506" y="70855"/>
                    <a:pt x="1885182" y="72710"/>
                    <a:pt x="1871221" y="76200"/>
                  </a:cubicBezTo>
                  <a:cubicBezTo>
                    <a:pt x="1862563" y="78364"/>
                    <a:pt x="1854745" y="84544"/>
                    <a:pt x="1845821" y="84666"/>
                  </a:cubicBezTo>
                  <a:lnTo>
                    <a:pt x="635088" y="93133"/>
                  </a:lnTo>
                  <a:cubicBezTo>
                    <a:pt x="601221" y="98777"/>
                    <a:pt x="567234" y="103739"/>
                    <a:pt x="533488" y="110066"/>
                  </a:cubicBezTo>
                  <a:cubicBezTo>
                    <a:pt x="460589" y="123734"/>
                    <a:pt x="544112" y="115089"/>
                    <a:pt x="448821" y="127000"/>
                  </a:cubicBezTo>
                  <a:cubicBezTo>
                    <a:pt x="420677" y="130518"/>
                    <a:pt x="392298" y="131948"/>
                    <a:pt x="364154" y="135466"/>
                  </a:cubicBezTo>
                  <a:cubicBezTo>
                    <a:pt x="322637" y="140655"/>
                    <a:pt x="315936" y="143287"/>
                    <a:pt x="279488" y="152400"/>
                  </a:cubicBezTo>
                  <a:cubicBezTo>
                    <a:pt x="272791" y="185884"/>
                    <a:pt x="270436" y="238360"/>
                    <a:pt x="220221" y="245533"/>
                  </a:cubicBezTo>
                  <a:lnTo>
                    <a:pt x="101688" y="262466"/>
                  </a:lnTo>
                  <a:cubicBezTo>
                    <a:pt x="58779" y="305375"/>
                    <a:pt x="114312" y="254891"/>
                    <a:pt x="59354" y="287866"/>
                  </a:cubicBezTo>
                  <a:cubicBezTo>
                    <a:pt x="52509" y="291973"/>
                    <a:pt x="48654" y="299813"/>
                    <a:pt x="42421" y="304800"/>
                  </a:cubicBezTo>
                  <a:cubicBezTo>
                    <a:pt x="34475" y="311157"/>
                    <a:pt x="25488" y="316089"/>
                    <a:pt x="17021" y="321733"/>
                  </a:cubicBezTo>
                  <a:cubicBezTo>
                    <a:pt x="14199" y="338666"/>
                    <a:pt x="11921" y="355699"/>
                    <a:pt x="8554" y="372533"/>
                  </a:cubicBezTo>
                  <a:cubicBezTo>
                    <a:pt x="6272" y="383943"/>
                    <a:pt x="1246" y="394821"/>
                    <a:pt x="88" y="406400"/>
                  </a:cubicBezTo>
                  <a:cubicBezTo>
                    <a:pt x="-1597" y="423249"/>
                    <a:pt x="21255" y="434622"/>
                    <a:pt x="25488" y="440266"/>
                  </a:cubicBezTo>
                  <a:close/>
                </a:path>
              </a:pathLst>
            </a:custGeom>
            <a:solidFill>
              <a:srgbClr val="D9D9D9"/>
            </a:solidFill>
            <a:ln>
              <a:solidFill>
                <a:srgbClr val="D9D9D9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5" name="Straight Connector 14"/>
            <p:cNvCxnSpPr/>
            <p:nvPr/>
          </p:nvCxnSpPr>
          <p:spPr>
            <a:xfrm>
              <a:off x="2990212" y="3746496"/>
              <a:ext cx="3698455" cy="16933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6"/>
            <p:cNvCxnSpPr/>
            <p:nvPr/>
          </p:nvCxnSpPr>
          <p:spPr>
            <a:xfrm>
              <a:off x="4842933" y="1969287"/>
              <a:ext cx="0" cy="1802609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/>
            <p:cNvCxnSpPr/>
            <p:nvPr/>
          </p:nvCxnSpPr>
          <p:spPr>
            <a:xfrm>
              <a:off x="2990212" y="2181360"/>
              <a:ext cx="0" cy="1548367"/>
            </a:xfrm>
            <a:prstGeom prst="line">
              <a:avLst/>
            </a:prstGeom>
            <a:ln w="9525" cmpd="sng">
              <a:solidFill>
                <a:srgbClr val="000000"/>
              </a:solidFill>
              <a:prstDash val="dash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/>
            <p:cNvCxnSpPr/>
            <p:nvPr/>
          </p:nvCxnSpPr>
          <p:spPr>
            <a:xfrm>
              <a:off x="6688667" y="2176783"/>
              <a:ext cx="0" cy="1586646"/>
            </a:xfrm>
            <a:prstGeom prst="line">
              <a:avLst/>
            </a:prstGeom>
            <a:ln w="9525" cmpd="sng">
              <a:solidFill>
                <a:srgbClr val="000000"/>
              </a:solidFill>
              <a:prstDash val="dash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TextBox 30"/>
            <p:cNvSpPr txBox="1"/>
            <p:nvPr/>
          </p:nvSpPr>
          <p:spPr>
            <a:xfrm>
              <a:off x="6426007" y="3525721"/>
              <a:ext cx="262662" cy="276999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</a:t>
              </a:r>
              <a:endParaRPr lang="en-US" sz="1200" dirty="0"/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4711602" y="1692288"/>
              <a:ext cx="262662" cy="276999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2</a:t>
              </a:r>
            </a:p>
          </p:txBody>
        </p:sp>
        <p:cxnSp>
          <p:nvCxnSpPr>
            <p:cNvPr id="41" name="Straight Connector 40"/>
            <p:cNvCxnSpPr/>
            <p:nvPr/>
          </p:nvCxnSpPr>
          <p:spPr>
            <a:xfrm>
              <a:off x="4703135" y="2603494"/>
              <a:ext cx="262662" cy="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/>
            <p:cNvCxnSpPr/>
            <p:nvPr/>
          </p:nvCxnSpPr>
          <p:spPr>
            <a:xfrm>
              <a:off x="4707272" y="3132657"/>
              <a:ext cx="262662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TextBox 42"/>
            <p:cNvSpPr txBox="1"/>
            <p:nvPr/>
          </p:nvSpPr>
          <p:spPr>
            <a:xfrm>
              <a:off x="4986872" y="3911601"/>
              <a:ext cx="455022" cy="276999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liver</a:t>
              </a:r>
              <a:endParaRPr lang="en-US" sz="1200" dirty="0"/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4986872" y="1975157"/>
              <a:ext cx="1030814" cy="24622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000" dirty="0" err="1" smtClean="0"/>
                <a:t>Tumour</a:t>
              </a:r>
              <a:r>
                <a:rPr lang="en-US" sz="1000" dirty="0" smtClean="0"/>
                <a:t> - </a:t>
              </a:r>
              <a:r>
                <a:rPr lang="en-US" sz="1000" dirty="0" err="1" smtClean="0"/>
                <a:t>centre</a:t>
              </a:r>
              <a:endParaRPr lang="en-US" sz="1000" dirty="0"/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5054600" y="3402610"/>
              <a:ext cx="1210588" cy="24622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000" dirty="0" err="1" smtClean="0"/>
                <a:t>Tumour</a:t>
              </a:r>
              <a:r>
                <a:rPr lang="en-US" sz="1000" dirty="0" smtClean="0"/>
                <a:t> - periphery</a:t>
              </a:r>
              <a:endParaRPr lang="en-US" sz="1000" dirty="0"/>
            </a:p>
          </p:txBody>
        </p:sp>
        <p:sp>
          <p:nvSpPr>
            <p:cNvPr id="51" name="Rectangle 50"/>
            <p:cNvSpPr/>
            <p:nvPr/>
          </p:nvSpPr>
          <p:spPr>
            <a:xfrm>
              <a:off x="4711602" y="2048933"/>
              <a:ext cx="241398" cy="521101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" name="Rectangle 51"/>
            <p:cNvSpPr/>
            <p:nvPr/>
          </p:nvSpPr>
          <p:spPr>
            <a:xfrm>
              <a:off x="4722234" y="3174992"/>
              <a:ext cx="241398" cy="545299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54" name="Straight Connector 53"/>
            <p:cNvCxnSpPr>
              <a:stCxn id="57" idx="3"/>
              <a:endCxn id="51" idx="1"/>
            </p:cNvCxnSpPr>
            <p:nvPr/>
          </p:nvCxnSpPr>
          <p:spPr>
            <a:xfrm flipV="1">
              <a:off x="2772221" y="2309484"/>
              <a:ext cx="1939381" cy="494065"/>
            </a:xfrm>
            <a:prstGeom prst="line">
              <a:avLst/>
            </a:prstGeom>
            <a:ln w="12700" cmpd="sng">
              <a:solidFill>
                <a:srgbClr val="000000"/>
              </a:solidFill>
              <a:headEnd type="none"/>
              <a:tailEnd type="arrow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Straight Connector 55"/>
            <p:cNvCxnSpPr>
              <a:stCxn id="57" idx="3"/>
              <a:endCxn id="52" idx="1"/>
            </p:cNvCxnSpPr>
            <p:nvPr/>
          </p:nvCxnSpPr>
          <p:spPr>
            <a:xfrm>
              <a:off x="2772221" y="2803549"/>
              <a:ext cx="1950013" cy="644093"/>
            </a:xfrm>
            <a:prstGeom prst="line">
              <a:avLst/>
            </a:prstGeom>
            <a:ln w="12700" cmpd="sng">
              <a:solidFill>
                <a:srgbClr val="000000"/>
              </a:solidFill>
              <a:headEnd type="none"/>
              <a:tailEnd type="arrow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TextBox 56"/>
            <p:cNvSpPr txBox="1"/>
            <p:nvPr/>
          </p:nvSpPr>
          <p:spPr>
            <a:xfrm>
              <a:off x="1908032" y="2603494"/>
              <a:ext cx="864189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Boxes placed </a:t>
              </a:r>
            </a:p>
            <a:p>
              <a:r>
                <a:rPr lang="en-US" sz="1000" dirty="0" smtClean="0"/>
                <a:t>for counting</a:t>
              </a:r>
              <a:endParaRPr lang="en-US" sz="1000" dirty="0"/>
            </a:p>
          </p:txBody>
        </p:sp>
      </p:grpSp>
    </p:spTree>
    <p:extLst>
      <p:ext uri="{BB962C8B-B14F-4D97-AF65-F5344CB8AC3E}">
        <p14:creationId xmlns="" xmlns:p14="http://schemas.microsoft.com/office/powerpoint/2010/main" val="2881858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7</TotalTime>
  <Words>128</Words>
  <Application>Microsoft Office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m Jones</dc:creator>
  <cp:lastModifiedBy>Owner</cp:lastModifiedBy>
  <cp:revision>13</cp:revision>
  <cp:lastPrinted>2012-06-16T12:38:45Z</cp:lastPrinted>
  <dcterms:created xsi:type="dcterms:W3CDTF">2012-06-15T12:49:09Z</dcterms:created>
  <dcterms:modified xsi:type="dcterms:W3CDTF">2012-07-20T14:37:19Z</dcterms:modified>
</cp:coreProperties>
</file>